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  <p:sldId id="257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image" Target="../media/image4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wmf"/><Relationship Id="rId1" Type="http://schemas.openxmlformats.org/officeDocument/2006/relationships/image" Target="../media/image6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wmf"/><Relationship Id="rId1" Type="http://schemas.openxmlformats.org/officeDocument/2006/relationships/image" Target="../media/image8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792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483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218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086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025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599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674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217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685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186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111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C54E16-93C2-4CA7-A32A-49B36F38EF63}" type="datetimeFigureOut">
              <a:rPr lang="en-US" smtClean="0"/>
              <a:t>3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3F38F6-9518-490B-8DD6-14CDFC0A18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476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6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8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44C8070-E40E-4A3B-A536-B95B082D9E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5027844"/>
              </p:ext>
            </p:extLst>
          </p:nvPr>
        </p:nvGraphicFramePr>
        <p:xfrm>
          <a:off x="2930358" y="2255118"/>
          <a:ext cx="1932329" cy="2301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0" r:id="rId3" imgW="7530120" imgH="8977680" progId="">
                  <p:embed/>
                </p:oleObj>
              </mc:Choice>
              <mc:Fallback>
                <p:oleObj r:id="rId3" imgW="7530120" imgH="8977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30358" y="2255118"/>
                        <a:ext cx="1932329" cy="2301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E2C4506-0212-4900-BEDB-C2C6EC6DC972}"/>
              </a:ext>
            </a:extLst>
          </p:cNvPr>
          <p:cNvSpPr txBox="1"/>
          <p:nvPr/>
        </p:nvSpPr>
        <p:spPr>
          <a:xfrm rot="18635767">
            <a:off x="3424178" y="2403554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63305BA-F33F-4B23-A3AD-01C1F46770FC}"/>
              </a:ext>
            </a:extLst>
          </p:cNvPr>
          <p:cNvSpPr txBox="1"/>
          <p:nvPr/>
        </p:nvSpPr>
        <p:spPr>
          <a:xfrm rot="18635767">
            <a:off x="3614458" y="2342049"/>
            <a:ext cx="6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C1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83AB87-A894-49A6-8815-0E127F30FB69}"/>
              </a:ext>
            </a:extLst>
          </p:cNvPr>
          <p:cNvSpPr txBox="1"/>
          <p:nvPr/>
        </p:nvSpPr>
        <p:spPr>
          <a:xfrm rot="18635767">
            <a:off x="3749459" y="2403554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pa1c1c7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30124D08-4D73-4A19-A0E2-9CE02BF4F961}"/>
              </a:ext>
            </a:extLst>
          </p:cNvPr>
          <p:cNvCxnSpPr/>
          <p:nvPr/>
        </p:nvCxnSpPr>
        <p:spPr>
          <a:xfrm flipH="1">
            <a:off x="4844036" y="3412735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9641A05-D5E7-418B-B9E5-6ACEB1DADD4F}"/>
              </a:ext>
            </a:extLst>
          </p:cNvPr>
          <p:cNvSpPr txBox="1"/>
          <p:nvPr/>
        </p:nvSpPr>
        <p:spPr>
          <a:xfrm>
            <a:off x="5187847" y="3181349"/>
            <a:ext cx="8483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itchFamily="34" charset="0"/>
              </a:rPr>
              <a:t>Gprc6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(189-537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E42686-1DC5-4C81-8587-13DE91CD8AB3}"/>
              </a:ext>
            </a:extLst>
          </p:cNvPr>
          <p:cNvSpPr txBox="1"/>
          <p:nvPr/>
        </p:nvSpPr>
        <p:spPr>
          <a:xfrm>
            <a:off x="8499272" y="3148733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itchFamily="34" charset="0"/>
              </a:rPr>
              <a:t>G3pdh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0F8284-7A3A-49A2-9F07-C38F9C1A4511}"/>
              </a:ext>
            </a:extLst>
          </p:cNvPr>
          <p:cNvSpPr txBox="1"/>
          <p:nvPr/>
        </p:nvSpPr>
        <p:spPr>
          <a:xfrm rot="18635767">
            <a:off x="4116608" y="2403555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0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A7BD4B0D-018F-44C0-A4BD-FB28B74B71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8615563"/>
              </p:ext>
            </p:extLst>
          </p:nvPr>
        </p:nvGraphicFramePr>
        <p:xfrm>
          <a:off x="6146456" y="2336485"/>
          <a:ext cx="2055383" cy="21850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1" r:id="rId5" imgW="8202960" imgH="8736480" progId="">
                  <p:embed/>
                </p:oleObj>
              </mc:Choice>
              <mc:Fallback>
                <p:oleObj r:id="rId5" imgW="8202960" imgH="873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46456" y="2336485"/>
                        <a:ext cx="2055383" cy="21850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AEE4A108-15BF-4719-B3BE-378FFDF28255}"/>
              </a:ext>
            </a:extLst>
          </p:cNvPr>
          <p:cNvSpPr txBox="1"/>
          <p:nvPr/>
        </p:nvSpPr>
        <p:spPr>
          <a:xfrm rot="18635767">
            <a:off x="1374886" y="757914"/>
            <a:ext cx="6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C1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CE55B1F-1A57-4BFB-B37E-056B7C16F140}"/>
              </a:ext>
            </a:extLst>
          </p:cNvPr>
          <p:cNvSpPr txBox="1"/>
          <p:nvPr/>
        </p:nvSpPr>
        <p:spPr>
          <a:xfrm rot="18635767">
            <a:off x="2129871" y="838874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pa1c1c7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72856CA-A12F-4457-A603-8A4831B52651}"/>
              </a:ext>
            </a:extLst>
          </p:cNvPr>
          <p:cNvCxnSpPr>
            <a:cxnSpLocks/>
          </p:cNvCxnSpPr>
          <p:nvPr/>
        </p:nvCxnSpPr>
        <p:spPr>
          <a:xfrm>
            <a:off x="6424955" y="2686724"/>
            <a:ext cx="559466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DB91640A-478A-48E2-9E14-666E9AB877B5}"/>
              </a:ext>
            </a:extLst>
          </p:cNvPr>
          <p:cNvSpPr txBox="1"/>
          <p:nvPr/>
        </p:nvSpPr>
        <p:spPr>
          <a:xfrm>
            <a:off x="733952" y="499976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6633BF4-EA16-44DE-987C-2357C414F0CD}"/>
              </a:ext>
            </a:extLst>
          </p:cNvPr>
          <p:cNvCxnSpPr/>
          <p:nvPr/>
        </p:nvCxnSpPr>
        <p:spPr>
          <a:xfrm flipH="1">
            <a:off x="8215086" y="3287233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9CBA83A-8524-485E-BA19-14A96872548A}"/>
              </a:ext>
            </a:extLst>
          </p:cNvPr>
          <p:cNvCxnSpPr>
            <a:cxnSpLocks/>
          </p:cNvCxnSpPr>
          <p:nvPr/>
        </p:nvCxnSpPr>
        <p:spPr>
          <a:xfrm>
            <a:off x="7068356" y="2686724"/>
            <a:ext cx="559466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9D32D56-B126-43B7-9DF9-624D34470858}"/>
              </a:ext>
            </a:extLst>
          </p:cNvPr>
          <p:cNvCxnSpPr>
            <a:cxnSpLocks/>
          </p:cNvCxnSpPr>
          <p:nvPr/>
        </p:nvCxnSpPr>
        <p:spPr>
          <a:xfrm>
            <a:off x="7711757" y="2686724"/>
            <a:ext cx="3334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69322B59-58CA-4B38-9F32-912B4056581D}"/>
              </a:ext>
            </a:extLst>
          </p:cNvPr>
          <p:cNvSpPr txBox="1"/>
          <p:nvPr/>
        </p:nvSpPr>
        <p:spPr>
          <a:xfrm>
            <a:off x="6449474" y="2471842"/>
            <a:ext cx="6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2C1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859CB68-1339-403E-A503-66B7CE0D5774}"/>
              </a:ext>
            </a:extLst>
          </p:cNvPr>
          <p:cNvSpPr txBox="1"/>
          <p:nvPr/>
        </p:nvSpPr>
        <p:spPr>
          <a:xfrm>
            <a:off x="6947658" y="2440502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pa1c1c7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C9FE78C-E9C1-4B93-98F8-B376B8C256E0}"/>
              </a:ext>
            </a:extLst>
          </p:cNvPr>
          <p:cNvSpPr txBox="1"/>
          <p:nvPr/>
        </p:nvSpPr>
        <p:spPr>
          <a:xfrm>
            <a:off x="7708154" y="2440503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20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D35BB93E-9F5E-4FA0-B427-3FC9E96C662A}"/>
              </a:ext>
            </a:extLst>
          </p:cNvPr>
          <p:cNvSpPr/>
          <p:nvPr/>
        </p:nvSpPr>
        <p:spPr>
          <a:xfrm>
            <a:off x="6398258" y="2812810"/>
            <a:ext cx="186951" cy="104737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5B235452-EC39-4D15-BBCC-E479D9A18F65}"/>
              </a:ext>
            </a:extLst>
          </p:cNvPr>
          <p:cNvSpPr/>
          <p:nvPr/>
        </p:nvSpPr>
        <p:spPr>
          <a:xfrm>
            <a:off x="7024544" y="2812810"/>
            <a:ext cx="186951" cy="104737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38AD3113-757A-4B1B-8C4F-B2FD084242FF}"/>
              </a:ext>
            </a:extLst>
          </p:cNvPr>
          <p:cNvSpPr/>
          <p:nvPr/>
        </p:nvSpPr>
        <p:spPr>
          <a:xfrm>
            <a:off x="7866640" y="2812810"/>
            <a:ext cx="186951" cy="1047376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89" name="Object 88">
            <a:extLst>
              <a:ext uri="{FF2B5EF4-FFF2-40B4-BE49-F238E27FC236}">
                <a16:creationId xmlns:a16="http://schemas.microsoft.com/office/drawing/2014/main" id="{8D9E21BC-5E52-44CC-8CF2-FF7B5786C9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9808728"/>
              </p:ext>
            </p:extLst>
          </p:nvPr>
        </p:nvGraphicFramePr>
        <p:xfrm>
          <a:off x="404378" y="2278212"/>
          <a:ext cx="1270130" cy="2265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2" r:id="rId7" imgW="3174480" imgH="5663160" progId="">
                  <p:embed/>
                </p:oleObj>
              </mc:Choice>
              <mc:Fallback>
                <p:oleObj r:id="rId7" imgW="3174480" imgH="5663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4378" y="2278212"/>
                        <a:ext cx="1270130" cy="2265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0" name="TextBox 89">
            <a:extLst>
              <a:ext uri="{FF2B5EF4-FFF2-40B4-BE49-F238E27FC236}">
                <a16:creationId xmlns:a16="http://schemas.microsoft.com/office/drawing/2014/main" id="{AA87BC19-C5BF-4E75-9551-70D9C606306B}"/>
              </a:ext>
            </a:extLst>
          </p:cNvPr>
          <p:cNvSpPr txBox="1"/>
          <p:nvPr/>
        </p:nvSpPr>
        <p:spPr>
          <a:xfrm rot="18635767">
            <a:off x="734222" y="2246049"/>
            <a:ext cx="6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2C1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6E7773F-E518-4A2A-BD72-DE2DAAC0FB63}"/>
              </a:ext>
            </a:extLst>
          </p:cNvPr>
          <p:cNvSpPr txBox="1"/>
          <p:nvPr/>
        </p:nvSpPr>
        <p:spPr>
          <a:xfrm rot="18635767">
            <a:off x="967135" y="2187451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epa1c1c7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3624DBF-FCA3-4174-BFC5-5F7A03B3421C}"/>
              </a:ext>
            </a:extLst>
          </p:cNvPr>
          <p:cNvSpPr txBox="1"/>
          <p:nvPr/>
        </p:nvSpPr>
        <p:spPr>
          <a:xfrm rot="18635767">
            <a:off x="1360529" y="2332156"/>
            <a:ext cx="4187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20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21FAB987-A007-42FF-85F9-BA0A6C737101}"/>
              </a:ext>
            </a:extLst>
          </p:cNvPr>
          <p:cNvCxnSpPr/>
          <p:nvPr/>
        </p:nvCxnSpPr>
        <p:spPr>
          <a:xfrm flipH="1">
            <a:off x="1680466" y="3367560"/>
            <a:ext cx="197812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23812F00-F438-4715-9E94-FB61610E35C2}"/>
              </a:ext>
            </a:extLst>
          </p:cNvPr>
          <p:cNvSpPr txBox="1"/>
          <p:nvPr/>
        </p:nvSpPr>
        <p:spPr>
          <a:xfrm>
            <a:off x="1835889" y="3234523"/>
            <a:ext cx="9332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itchFamily="34" charset="0"/>
              </a:rPr>
              <a:t>Gprc6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(737-1812)</a:t>
            </a:r>
          </a:p>
        </p:txBody>
      </p:sp>
    </p:spTree>
    <p:extLst>
      <p:ext uri="{BB962C8B-B14F-4D97-AF65-F5344CB8AC3E}">
        <p14:creationId xmlns:p14="http://schemas.microsoft.com/office/powerpoint/2010/main" val="909596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D1D1BEB-D701-4850-BBF9-B990F01F65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7874760"/>
              </p:ext>
            </p:extLst>
          </p:nvPr>
        </p:nvGraphicFramePr>
        <p:xfrm>
          <a:off x="5787143" y="2091847"/>
          <a:ext cx="1676220" cy="30426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6" r:id="rId3" imgW="3580920" imgH="6501240" progId="">
                  <p:embed/>
                </p:oleObj>
              </mc:Choice>
              <mc:Fallback>
                <p:oleObj r:id="rId3" imgW="3580920" imgH="6501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87143" y="2091847"/>
                        <a:ext cx="1676220" cy="30426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575555F-D37C-4DAE-BBB7-2E72F2C670DB}"/>
              </a:ext>
            </a:extLst>
          </p:cNvPr>
          <p:cNvCxnSpPr/>
          <p:nvPr/>
        </p:nvCxnSpPr>
        <p:spPr>
          <a:xfrm flipH="1">
            <a:off x="7532573" y="3548389"/>
            <a:ext cx="197812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27878CD7-688B-4BA7-B381-9F10EAD41F34}"/>
              </a:ext>
            </a:extLst>
          </p:cNvPr>
          <p:cNvSpPr txBox="1"/>
          <p:nvPr/>
        </p:nvSpPr>
        <p:spPr>
          <a:xfrm>
            <a:off x="7673867" y="3415352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itchFamily="34" charset="0"/>
              </a:rPr>
              <a:t>G3pdh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36E488-DFDE-4E6A-B3AD-B58BB336C661}"/>
              </a:ext>
            </a:extLst>
          </p:cNvPr>
          <p:cNvSpPr txBox="1"/>
          <p:nvPr/>
        </p:nvSpPr>
        <p:spPr>
          <a:xfrm>
            <a:off x="775711" y="805999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6A37836-0C02-4C57-ADE3-85E629B14E10}"/>
              </a:ext>
            </a:extLst>
          </p:cNvPr>
          <p:cNvSpPr txBox="1"/>
          <p:nvPr/>
        </p:nvSpPr>
        <p:spPr>
          <a:xfrm rot="19200000">
            <a:off x="5926469" y="2367523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2C12.ncsiRN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A9606A4-BAF3-485B-9438-5961FE38E5DB}"/>
              </a:ext>
            </a:extLst>
          </p:cNvPr>
          <p:cNvSpPr txBox="1"/>
          <p:nvPr/>
        </p:nvSpPr>
        <p:spPr>
          <a:xfrm rot="19200000">
            <a:off x="6194745" y="2443677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2C12.si49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75EF5DB-84C9-46B3-B603-6AD19D2EE89B}"/>
              </a:ext>
            </a:extLst>
          </p:cNvPr>
          <p:cNvSpPr txBox="1"/>
          <p:nvPr/>
        </p:nvSpPr>
        <p:spPr>
          <a:xfrm rot="19200000">
            <a:off x="6426966" y="2313956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pa1c1c7.si49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5B2E090-AFE1-4F96-BDEE-CCD103C5A04B}"/>
              </a:ext>
            </a:extLst>
          </p:cNvPr>
          <p:cNvSpPr txBox="1"/>
          <p:nvPr/>
        </p:nvSpPr>
        <p:spPr>
          <a:xfrm rot="19200000">
            <a:off x="6730305" y="256865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2O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5332D05-D5D8-4DFA-8C8B-2BD21A105051}"/>
              </a:ext>
            </a:extLst>
          </p:cNvPr>
          <p:cNvSpPr txBox="1"/>
          <p:nvPr/>
        </p:nvSpPr>
        <p:spPr>
          <a:xfrm rot="19200000">
            <a:off x="6927615" y="256263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2O</a:t>
            </a:r>
          </a:p>
        </p:txBody>
      </p:sp>
      <p:graphicFrame>
        <p:nvGraphicFramePr>
          <p:cNvPr id="50" name="Object 49">
            <a:extLst>
              <a:ext uri="{FF2B5EF4-FFF2-40B4-BE49-F238E27FC236}">
                <a16:creationId xmlns:a16="http://schemas.microsoft.com/office/drawing/2014/main" id="{A704988C-89D0-4E74-89D8-0B354214BE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8769752"/>
              </p:ext>
            </p:extLst>
          </p:nvPr>
        </p:nvGraphicFramePr>
        <p:xfrm>
          <a:off x="1494561" y="2070494"/>
          <a:ext cx="2867607" cy="31752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7" r:id="rId5" imgW="8482320" imgH="9409320" progId="">
                  <p:embed/>
                </p:oleObj>
              </mc:Choice>
              <mc:Fallback>
                <p:oleObj r:id="rId5" imgW="8482320" imgH="9409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494561" y="2070494"/>
                        <a:ext cx="2867607" cy="31752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" name="TextBox 50">
            <a:extLst>
              <a:ext uri="{FF2B5EF4-FFF2-40B4-BE49-F238E27FC236}">
                <a16:creationId xmlns:a16="http://schemas.microsoft.com/office/drawing/2014/main" id="{11B1E483-5A50-43E2-A69D-D5E928A83373}"/>
              </a:ext>
            </a:extLst>
          </p:cNvPr>
          <p:cNvSpPr txBox="1"/>
          <p:nvPr/>
        </p:nvSpPr>
        <p:spPr>
          <a:xfrm rot="19200000">
            <a:off x="3751642" y="265156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2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C3C4637-8953-4315-8972-DDB2EF7172EA}"/>
              </a:ext>
            </a:extLst>
          </p:cNvPr>
          <p:cNvSpPr txBox="1"/>
          <p:nvPr/>
        </p:nvSpPr>
        <p:spPr>
          <a:xfrm rot="19200000">
            <a:off x="1772671" y="2456201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2C12.ncsiRN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467B432-CB0F-42D4-96CE-AF27FD1082A8}"/>
              </a:ext>
            </a:extLst>
          </p:cNvPr>
          <p:cNvSpPr txBox="1"/>
          <p:nvPr/>
        </p:nvSpPr>
        <p:spPr>
          <a:xfrm rot="19200000">
            <a:off x="2145865" y="2530346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2C12.si49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547E774-1C9D-43CD-AB76-567D4B7062D1}"/>
              </a:ext>
            </a:extLst>
          </p:cNvPr>
          <p:cNvSpPr txBox="1"/>
          <p:nvPr/>
        </p:nvSpPr>
        <p:spPr>
          <a:xfrm rot="19200000">
            <a:off x="3350495" y="2428191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pa1c1c7.si539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FEB7FCB-45DE-4710-9551-DF123AA0FA4D}"/>
              </a:ext>
            </a:extLst>
          </p:cNvPr>
          <p:cNvSpPr txBox="1"/>
          <p:nvPr/>
        </p:nvSpPr>
        <p:spPr>
          <a:xfrm rot="19200000">
            <a:off x="1401557" y="2352038"/>
            <a:ext cx="14189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pa1c1c7.ncsiRNA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30B7B59-0513-48E8-9E85-7517FC0DA7EA}"/>
              </a:ext>
            </a:extLst>
          </p:cNvPr>
          <p:cNvSpPr txBox="1"/>
          <p:nvPr/>
        </p:nvSpPr>
        <p:spPr>
          <a:xfrm rot="19200000">
            <a:off x="2772666" y="2514229"/>
            <a:ext cx="9348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2C12.si53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2F40CB1-229A-4395-B5EB-17FC2584EDFC}"/>
              </a:ext>
            </a:extLst>
          </p:cNvPr>
          <p:cNvSpPr txBox="1"/>
          <p:nvPr/>
        </p:nvSpPr>
        <p:spPr>
          <a:xfrm rot="19200000">
            <a:off x="2443242" y="2444308"/>
            <a:ext cx="12025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pa1c1c7.si49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236B549-7E3E-4258-AB60-0DBEDFDAA43D}"/>
              </a:ext>
            </a:extLst>
          </p:cNvPr>
          <p:cNvSpPr txBox="1"/>
          <p:nvPr/>
        </p:nvSpPr>
        <p:spPr>
          <a:xfrm rot="19200000">
            <a:off x="3052017" y="2358640"/>
            <a:ext cx="14189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epa1c1c7.ncsiRNA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AC81DC1A-C866-4164-8B4D-F744CC6E5E06}"/>
              </a:ext>
            </a:extLst>
          </p:cNvPr>
          <p:cNvSpPr/>
          <p:nvPr/>
        </p:nvSpPr>
        <p:spPr>
          <a:xfrm>
            <a:off x="1887190" y="2313704"/>
            <a:ext cx="962782" cy="24891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2B84C581-9A36-4808-9B64-663F14E84662}"/>
              </a:ext>
            </a:extLst>
          </p:cNvPr>
          <p:cNvSpPr/>
          <p:nvPr/>
        </p:nvSpPr>
        <p:spPr>
          <a:xfrm>
            <a:off x="3753998" y="2313704"/>
            <a:ext cx="284040" cy="24891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2982E9C7-54AD-4328-84F8-BB51840686BF}"/>
              </a:ext>
            </a:extLst>
          </p:cNvPr>
          <p:cNvCxnSpPr/>
          <p:nvPr/>
        </p:nvCxnSpPr>
        <p:spPr>
          <a:xfrm flipH="1">
            <a:off x="4397713" y="3303229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90E62FE9-0009-403F-993F-771F5F880241}"/>
              </a:ext>
            </a:extLst>
          </p:cNvPr>
          <p:cNvSpPr txBox="1"/>
          <p:nvPr/>
        </p:nvSpPr>
        <p:spPr>
          <a:xfrm>
            <a:off x="4741524" y="3071843"/>
            <a:ext cx="8483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itchFamily="34" charset="0"/>
              </a:rPr>
              <a:t>Gprc6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(189-537)</a:t>
            </a:r>
          </a:p>
        </p:txBody>
      </p:sp>
    </p:spTree>
    <p:extLst>
      <p:ext uri="{BB962C8B-B14F-4D97-AF65-F5344CB8AC3E}">
        <p14:creationId xmlns:p14="http://schemas.microsoft.com/office/powerpoint/2010/main" val="1282168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E8B5D46D-0213-4227-9BD8-421487AB8F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941407"/>
              </p:ext>
            </p:extLst>
          </p:nvPr>
        </p:nvGraphicFramePr>
        <p:xfrm>
          <a:off x="2512432" y="1615445"/>
          <a:ext cx="1186443" cy="39350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r:id="rId3" imgW="190440" imgH="632160" progId="">
                  <p:embed/>
                </p:oleObj>
              </mc:Choice>
              <mc:Fallback>
                <p:oleObj r:id="rId3" imgW="190440" imgH="6321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2432" y="1615445"/>
                        <a:ext cx="1186443" cy="39350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F8C91FB3-6F9E-4782-879B-74CD8095E410}"/>
              </a:ext>
            </a:extLst>
          </p:cNvPr>
          <p:cNvCxnSpPr/>
          <p:nvPr/>
        </p:nvCxnSpPr>
        <p:spPr>
          <a:xfrm flipH="1">
            <a:off x="6084762" y="3875487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EAAE494C-B129-4056-BA49-BAC56D631D5C}"/>
              </a:ext>
            </a:extLst>
          </p:cNvPr>
          <p:cNvSpPr txBox="1"/>
          <p:nvPr/>
        </p:nvSpPr>
        <p:spPr>
          <a:xfrm>
            <a:off x="6420321" y="3736987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BF55BF5-B763-4744-AFAB-BC5109D544E0}"/>
              </a:ext>
            </a:extLst>
          </p:cNvPr>
          <p:cNvCxnSpPr/>
          <p:nvPr/>
        </p:nvCxnSpPr>
        <p:spPr>
          <a:xfrm flipH="1">
            <a:off x="3749879" y="4404220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7330C40D-8A47-47DB-AD20-623B2C489126}"/>
              </a:ext>
            </a:extLst>
          </p:cNvPr>
          <p:cNvSpPr txBox="1"/>
          <p:nvPr/>
        </p:nvSpPr>
        <p:spPr>
          <a:xfrm>
            <a:off x="4085438" y="426572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D1DC46-CF96-43DA-8359-D411BAB7CC00}"/>
              </a:ext>
            </a:extLst>
          </p:cNvPr>
          <p:cNvSpPr txBox="1"/>
          <p:nvPr/>
        </p:nvSpPr>
        <p:spPr>
          <a:xfrm rot="19200000">
            <a:off x="2488395" y="1158927"/>
            <a:ext cx="11160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C2C12.ncsiRN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511262-D03F-4DB5-9858-D6F423C16279}"/>
              </a:ext>
            </a:extLst>
          </p:cNvPr>
          <p:cNvSpPr txBox="1"/>
          <p:nvPr/>
        </p:nvSpPr>
        <p:spPr>
          <a:xfrm rot="19200000">
            <a:off x="2745273" y="1119264"/>
            <a:ext cx="1208948" cy="3228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C2C12.si49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18F3208-2AAE-44E5-959B-9DF9CAD81DFB}"/>
              </a:ext>
            </a:extLst>
          </p:cNvPr>
          <p:cNvSpPr txBox="1"/>
          <p:nvPr/>
        </p:nvSpPr>
        <p:spPr>
          <a:xfrm rot="19200000">
            <a:off x="3217459" y="1139211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Hepa1c1c7.si49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E35071-54AB-4147-A65F-DE4DA9DF32E5}"/>
              </a:ext>
            </a:extLst>
          </p:cNvPr>
          <p:cNvSpPr txBox="1"/>
          <p:nvPr/>
        </p:nvSpPr>
        <p:spPr>
          <a:xfrm rot="19200000">
            <a:off x="2968618" y="1050532"/>
            <a:ext cx="1398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Hepa1c1c7.ncsiRN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0C8AF6-FCEC-48AE-9FE5-C7A7B92AD495}"/>
              </a:ext>
            </a:extLst>
          </p:cNvPr>
          <p:cNvSpPr txBox="1"/>
          <p:nvPr/>
        </p:nvSpPr>
        <p:spPr>
          <a:xfrm rot="19200000">
            <a:off x="4984169" y="1108160"/>
            <a:ext cx="11512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C2C12.ncsiRN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5636114-8342-4045-95F6-0774B95FAA15}"/>
              </a:ext>
            </a:extLst>
          </p:cNvPr>
          <p:cNvSpPr txBox="1"/>
          <p:nvPr/>
        </p:nvSpPr>
        <p:spPr>
          <a:xfrm rot="19200000">
            <a:off x="5249034" y="1058693"/>
            <a:ext cx="1208948" cy="3228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C2C12.si49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A9FF6AC-93E7-408E-A2D2-DF047D0D3F0D}"/>
              </a:ext>
            </a:extLst>
          </p:cNvPr>
          <p:cNvSpPr txBox="1"/>
          <p:nvPr/>
        </p:nvSpPr>
        <p:spPr>
          <a:xfrm rot="19200000">
            <a:off x="5688000" y="1102492"/>
            <a:ext cx="1168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Hepa1c1c7.si49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6917892-9706-46E0-853A-F1E15470E7B0}"/>
              </a:ext>
            </a:extLst>
          </p:cNvPr>
          <p:cNvSpPr txBox="1"/>
          <p:nvPr/>
        </p:nvSpPr>
        <p:spPr>
          <a:xfrm rot="19200000">
            <a:off x="5428963" y="1028819"/>
            <a:ext cx="1398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itchFamily="34" charset="0"/>
                <a:cs typeface="Arial" pitchFamily="34" charset="0"/>
              </a:rPr>
              <a:t>Hepa1c1c7.ncsiRN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E5F2132-C3B9-4827-8E3D-663C982C6F60}"/>
              </a:ext>
            </a:extLst>
          </p:cNvPr>
          <p:cNvSpPr txBox="1"/>
          <p:nvPr/>
        </p:nvSpPr>
        <p:spPr>
          <a:xfrm>
            <a:off x="953223" y="511465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9E94CDE-2A45-4AE7-ABC5-9FEE06AFA8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754823"/>
              </p:ext>
            </p:extLst>
          </p:nvPr>
        </p:nvGraphicFramePr>
        <p:xfrm>
          <a:off x="5102453" y="1611316"/>
          <a:ext cx="983357" cy="3943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r:id="rId5" imgW="156960" imgH="630720" progId="">
                  <p:embed/>
                </p:oleObj>
              </mc:Choice>
              <mc:Fallback>
                <p:oleObj r:id="rId5" imgW="156960" imgH="6307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102453" y="1611316"/>
                        <a:ext cx="983357" cy="39433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473109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7B8F8A3C-86F2-41DE-9471-BD663F0B7B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5245074"/>
              </p:ext>
            </p:extLst>
          </p:nvPr>
        </p:nvGraphicFramePr>
        <p:xfrm>
          <a:off x="2079560" y="1702800"/>
          <a:ext cx="1390650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r:id="rId3" imgW="3428280" imgH="10056960" progId="">
                  <p:embed/>
                </p:oleObj>
              </mc:Choice>
              <mc:Fallback>
                <p:oleObj r:id="rId3" imgW="3428280" imgH="100569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79560" y="1702800"/>
                        <a:ext cx="1390650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FCEF36D7-B0E7-48DC-A19B-AE8FA8A2752B}"/>
              </a:ext>
            </a:extLst>
          </p:cNvPr>
          <p:cNvCxnSpPr/>
          <p:nvPr/>
        </p:nvCxnSpPr>
        <p:spPr>
          <a:xfrm flipH="1">
            <a:off x="3473042" y="3280095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9D7B11E-561D-4E88-BA87-841C4E58D6AA}"/>
              </a:ext>
            </a:extLst>
          </p:cNvPr>
          <p:cNvSpPr txBox="1"/>
          <p:nvPr/>
        </p:nvSpPr>
        <p:spPr>
          <a:xfrm>
            <a:off x="3808601" y="3141595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7F754A5-5A3B-47D2-BCFD-B66A34FE26B7}"/>
              </a:ext>
            </a:extLst>
          </p:cNvPr>
          <p:cNvCxnSpPr/>
          <p:nvPr/>
        </p:nvCxnSpPr>
        <p:spPr>
          <a:xfrm>
            <a:off x="2273416" y="1715466"/>
            <a:ext cx="5033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ECFA611-9B48-429C-9DF3-3B8F889F81C5}"/>
              </a:ext>
            </a:extLst>
          </p:cNvPr>
          <p:cNvCxnSpPr/>
          <p:nvPr/>
        </p:nvCxnSpPr>
        <p:spPr>
          <a:xfrm>
            <a:off x="2870432" y="1715466"/>
            <a:ext cx="5033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 Box 426">
            <a:extLst>
              <a:ext uri="{FF2B5EF4-FFF2-40B4-BE49-F238E27FC236}">
                <a16:creationId xmlns:a16="http://schemas.microsoft.com/office/drawing/2014/main" id="{3D5FE595-06A8-4EDE-81FE-E7E20991609D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2141362" y="1303579"/>
            <a:ext cx="678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5" name="Text Box 427">
            <a:extLst>
              <a:ext uri="{FF2B5EF4-FFF2-40B4-BE49-F238E27FC236}">
                <a16:creationId xmlns:a16="http://schemas.microsoft.com/office/drawing/2014/main" id="{F31DF8B1-FE6C-47EE-97DE-3A25AB2B40FE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2402748" y="1153482"/>
            <a:ext cx="11029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-cko</a:t>
            </a:r>
          </a:p>
        </p:txBody>
      </p:sp>
      <p:sp>
        <p:nvSpPr>
          <p:cNvPr id="16" name="Text Box 426">
            <a:extLst>
              <a:ext uri="{FF2B5EF4-FFF2-40B4-BE49-F238E27FC236}">
                <a16:creationId xmlns:a16="http://schemas.microsoft.com/office/drawing/2014/main" id="{113B8F2E-3A36-4FB9-9888-920700AAF8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6103" y="1718887"/>
            <a:ext cx="8322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</p:txBody>
      </p:sp>
      <p:sp>
        <p:nvSpPr>
          <p:cNvPr id="17" name="Text Box 426">
            <a:extLst>
              <a:ext uri="{FF2B5EF4-FFF2-40B4-BE49-F238E27FC236}">
                <a16:creationId xmlns:a16="http://schemas.microsoft.com/office/drawing/2014/main" id="{E9B0D30F-1531-43A8-ABAC-A58358606B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1955" y="1718887"/>
            <a:ext cx="516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18" name="Text Box 426">
            <a:extLst>
              <a:ext uri="{FF2B5EF4-FFF2-40B4-BE49-F238E27FC236}">
                <a16:creationId xmlns:a16="http://schemas.microsoft.com/office/drawing/2014/main" id="{65DE8DCB-2A27-44A1-AE88-B8D3F844CE24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2855659" y="1303579"/>
            <a:ext cx="678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9" name="Text Box 427">
            <a:extLst>
              <a:ext uri="{FF2B5EF4-FFF2-40B4-BE49-F238E27FC236}">
                <a16:creationId xmlns:a16="http://schemas.microsoft.com/office/drawing/2014/main" id="{0808BD52-8B91-4DF1-89DE-7B1AB6318AA6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3117046" y="1153482"/>
            <a:ext cx="11029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-cko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0F415AEC-F83F-465E-9ED3-2554370478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2531071"/>
              </p:ext>
            </p:extLst>
          </p:nvPr>
        </p:nvGraphicFramePr>
        <p:xfrm>
          <a:off x="4870689" y="1779860"/>
          <a:ext cx="1411287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r:id="rId5" imgW="3695040" imgH="10679040" progId="">
                  <p:embed/>
                </p:oleObj>
              </mc:Choice>
              <mc:Fallback>
                <p:oleObj r:id="rId5" imgW="3695040" imgH="106790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70689" y="1779860"/>
                        <a:ext cx="1411287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7B152101-27B6-438F-BA28-017106EEF1B3}"/>
              </a:ext>
            </a:extLst>
          </p:cNvPr>
          <p:cNvCxnSpPr/>
          <p:nvPr/>
        </p:nvCxnSpPr>
        <p:spPr>
          <a:xfrm flipH="1">
            <a:off x="6252590" y="4137170"/>
            <a:ext cx="33555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334CC0D-B3EA-4169-8A2A-B312ED580203}"/>
              </a:ext>
            </a:extLst>
          </p:cNvPr>
          <p:cNvSpPr txBox="1"/>
          <p:nvPr/>
        </p:nvSpPr>
        <p:spPr>
          <a:xfrm>
            <a:off x="6588149" y="3998670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B0B0018-AB33-459B-BDE7-9970DF5276A3}"/>
              </a:ext>
            </a:extLst>
          </p:cNvPr>
          <p:cNvCxnSpPr/>
          <p:nvPr/>
        </p:nvCxnSpPr>
        <p:spPr>
          <a:xfrm>
            <a:off x="4976068" y="1963098"/>
            <a:ext cx="5033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D510844-0B48-4296-9E75-48E360002F03}"/>
              </a:ext>
            </a:extLst>
          </p:cNvPr>
          <p:cNvCxnSpPr/>
          <p:nvPr/>
        </p:nvCxnSpPr>
        <p:spPr>
          <a:xfrm>
            <a:off x="5573084" y="1963098"/>
            <a:ext cx="5033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 Box 426">
            <a:extLst>
              <a:ext uri="{FF2B5EF4-FFF2-40B4-BE49-F238E27FC236}">
                <a16:creationId xmlns:a16="http://schemas.microsoft.com/office/drawing/2014/main" id="{142F3D11-C50D-4887-8BE9-380CF8103BEB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4844014" y="1551211"/>
            <a:ext cx="678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6" name="Text Box 427">
            <a:extLst>
              <a:ext uri="{FF2B5EF4-FFF2-40B4-BE49-F238E27FC236}">
                <a16:creationId xmlns:a16="http://schemas.microsoft.com/office/drawing/2014/main" id="{F59A4948-000E-4F71-9ED4-ACC3C3CB0458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5105400" y="1401114"/>
            <a:ext cx="11029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-cko</a:t>
            </a:r>
          </a:p>
        </p:txBody>
      </p:sp>
      <p:sp>
        <p:nvSpPr>
          <p:cNvPr id="27" name="Text Box 426">
            <a:extLst>
              <a:ext uri="{FF2B5EF4-FFF2-40B4-BE49-F238E27FC236}">
                <a16:creationId xmlns:a16="http://schemas.microsoft.com/office/drawing/2014/main" id="{B4620366-0CF6-429B-BA89-38B3C3DA01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68755" y="1966519"/>
            <a:ext cx="8322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</a:p>
        </p:txBody>
      </p:sp>
      <p:sp>
        <p:nvSpPr>
          <p:cNvPr id="28" name="Text Box 426">
            <a:extLst>
              <a:ext uri="{FF2B5EF4-FFF2-40B4-BE49-F238E27FC236}">
                <a16:creationId xmlns:a16="http://schemas.microsoft.com/office/drawing/2014/main" id="{1471CC67-014B-4701-9CE3-8DBE5F11DC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4607" y="1966519"/>
            <a:ext cx="5164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29" name="Text Box 426">
            <a:extLst>
              <a:ext uri="{FF2B5EF4-FFF2-40B4-BE49-F238E27FC236}">
                <a16:creationId xmlns:a16="http://schemas.microsoft.com/office/drawing/2014/main" id="{F602D8E5-B51B-43F0-A59A-59881119DA27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5558311" y="1551211"/>
            <a:ext cx="6783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0" name="Text Box 427">
            <a:extLst>
              <a:ext uri="{FF2B5EF4-FFF2-40B4-BE49-F238E27FC236}">
                <a16:creationId xmlns:a16="http://schemas.microsoft.com/office/drawing/2014/main" id="{B4A063A1-3967-4C71-9955-CEF6A17557C7}"/>
              </a:ext>
            </a:extLst>
          </p:cNvPr>
          <p:cNvSpPr txBox="1">
            <a:spLocks noChangeArrowheads="1"/>
          </p:cNvSpPr>
          <p:nvPr/>
        </p:nvSpPr>
        <p:spPr bwMode="auto">
          <a:xfrm rot="18900000">
            <a:off x="5819698" y="1401114"/>
            <a:ext cx="11029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prc6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Liver-cko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6A58F8A-9D5B-4F84-82AD-60452B999938}"/>
              </a:ext>
            </a:extLst>
          </p:cNvPr>
          <p:cNvSpPr txBox="1"/>
          <p:nvPr/>
        </p:nvSpPr>
        <p:spPr>
          <a:xfrm>
            <a:off x="628365" y="434770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2b</a:t>
            </a:r>
          </a:p>
        </p:txBody>
      </p:sp>
    </p:spTree>
    <p:extLst>
      <p:ext uri="{BB962C8B-B14F-4D97-AF65-F5344CB8AC3E}">
        <p14:creationId xmlns:p14="http://schemas.microsoft.com/office/powerpoint/2010/main" val="240182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3</TotalTime>
  <Words>107</Words>
  <Application>Microsoft Office PowerPoint</Application>
  <PresentationFormat>On-screen Show (4:3)</PresentationFormat>
  <Paragraphs>61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, Min</dc:creator>
  <cp:lastModifiedBy>Pi, Min</cp:lastModifiedBy>
  <cp:revision>23</cp:revision>
  <dcterms:created xsi:type="dcterms:W3CDTF">2020-01-10T15:50:12Z</dcterms:created>
  <dcterms:modified xsi:type="dcterms:W3CDTF">2020-03-03T21:43:11Z</dcterms:modified>
</cp:coreProperties>
</file>